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41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2700" autoAdjust="0"/>
  </p:normalViewPr>
  <p:slideViewPr>
    <p:cSldViewPr snapToGrid="0">
      <p:cViewPr varScale="1">
        <p:scale>
          <a:sx n="91" d="100"/>
          <a:sy n="91" d="100"/>
        </p:scale>
        <p:origin x="57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DDC5AC-E5EB-4F14-8DC9-2CF826FBE89B}" type="datetimeFigureOut">
              <a:rPr lang="zh-CN" altLang="en-US" smtClean="0"/>
              <a:t>2025/11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BCA577-315B-4C9C-9144-40954E5857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02156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4AC77F-7A8B-D71B-6A6C-4DD322329BC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8E7793A-C10B-2D4B-8EAD-0D2A603088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2585BF5-8569-DEDA-0435-92B312C4B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52C2D-6B39-45F5-BEC3-A17D28DBCB7D}" type="datetimeFigureOut">
              <a:rPr lang="zh-CN" altLang="en-US" smtClean="0"/>
              <a:t>2025/1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268DAB-F6C3-3948-6B3E-3DEBF36EA7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D05E70B-9A70-01FD-1ED3-C999DEAF77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612F-B608-4034-BC25-854815F166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2370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A70240-95AE-E660-E08E-D7D585D6D1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43F0DD8-06D3-0830-9D9D-E08D9B6B79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4424900-C5FD-EF0A-43D6-B81178306C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52C2D-6B39-45F5-BEC3-A17D28DBCB7D}" type="datetimeFigureOut">
              <a:rPr lang="zh-CN" altLang="en-US" smtClean="0"/>
              <a:t>2025/1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ACFA886-111C-85F1-1480-0B7C7F5C8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CEA7040-0504-99C8-6D16-46A09887D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612F-B608-4034-BC25-854815F166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2456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D0398B0-53E6-BF2A-65E1-6811240431A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582438B-C79A-85AA-C352-AD0642EAC6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526963F-3D92-AEEA-CF92-E74F368D5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52C2D-6B39-45F5-BEC3-A17D28DBCB7D}" type="datetimeFigureOut">
              <a:rPr lang="zh-CN" altLang="en-US" smtClean="0"/>
              <a:t>2025/1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170ECFF-8D70-E0A8-CB1F-BBFD5CA79E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9FAA60-74F9-20D0-43D7-E3BC15277C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612F-B608-4034-BC25-854815F166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1970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0B2740-5DC1-E4E6-BC1D-EC17E51043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4784D5D-D98B-EFE6-0C66-C1DF6872B7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A5697D-E5C8-5D39-3D8C-577FF28E7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52C2D-6B39-45F5-BEC3-A17D28DBCB7D}" type="datetimeFigureOut">
              <a:rPr lang="zh-CN" altLang="en-US" smtClean="0"/>
              <a:t>2025/1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B351C1D-20EA-37E0-1E50-B9875660B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D92593D-9D66-E41D-559A-484C6A382D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612F-B608-4034-BC25-854815F166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1888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CC42F5-8D2A-B333-57B6-15B3515DE8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ADF707C-5A79-07A0-CBC2-0060CB8A00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67E1C65-8C54-00AC-C401-D78A1FB7D6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52C2D-6B39-45F5-BEC3-A17D28DBCB7D}" type="datetimeFigureOut">
              <a:rPr lang="zh-CN" altLang="en-US" smtClean="0"/>
              <a:t>2025/1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1EB7048-9F77-1C6F-6D25-B31D087A3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3202761-73C3-301A-26B4-1C9343283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612F-B608-4034-BC25-854815F166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4195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E4AF3F-38FB-6F21-3FEA-88F3742521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76CE492-9BBE-9B93-DC83-7F85EF7E01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6D97012-4349-1559-C412-81FAE306AB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A03C876-288F-68C1-EFD0-97DAFC28CA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52C2D-6B39-45F5-BEC3-A17D28DBCB7D}" type="datetimeFigureOut">
              <a:rPr lang="zh-CN" altLang="en-US" smtClean="0"/>
              <a:t>2025/11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8B690CB-9A27-F436-C871-B8BA3905FA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93C7D13-8291-51B0-07B4-20EFDC98A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612F-B608-4034-BC25-854815F166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6573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B0739D-04CA-0364-2731-F45C05E728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7AD15BE-74F6-8322-9007-0295692062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B9CBB02-1B29-4E68-F65A-76141DE445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FC56A71-DAA8-0F88-78EC-2AD7B2220A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73388A9-A84A-28CE-5803-D256D1FF50A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869A538-7FAE-F960-78EE-08E676E50A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52C2D-6B39-45F5-BEC3-A17D28DBCB7D}" type="datetimeFigureOut">
              <a:rPr lang="zh-CN" altLang="en-US" smtClean="0"/>
              <a:t>2025/11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5B82AA6-AF26-2F11-0FED-23344A253F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1CE04E6-D4E9-D912-1A79-51C6FB658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612F-B608-4034-BC25-854815F166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3402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0B1834A-00C1-E1F5-6692-16C76DEA72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05ED269-1A16-84AA-4F9B-C8643E938A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52C2D-6B39-45F5-BEC3-A17D28DBCB7D}" type="datetimeFigureOut">
              <a:rPr lang="zh-CN" altLang="en-US" smtClean="0"/>
              <a:t>2025/11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8973A33-0499-7E2B-0E40-0FA71D14D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A447668-B0EE-A12B-663A-6DE3C3E941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612F-B608-4034-BC25-854815F166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8118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5217925-49E4-F4B6-5E4F-181BAC6CC9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52C2D-6B39-45F5-BEC3-A17D28DBCB7D}" type="datetimeFigureOut">
              <a:rPr lang="zh-CN" altLang="en-US" smtClean="0"/>
              <a:t>2025/11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83245FD-7095-2617-3A2B-1C369D003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D6F31D4-C005-C740-34DF-4E9E84E5A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612F-B608-4034-BC25-854815F166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6021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E0C368-16D7-FD52-8F88-F3ADCD9D17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4B8E88B-7EA0-69F5-5723-D31135A1662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EE96E9F-87E7-E669-5C4A-301B8F2C18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D60341A-96BD-F46E-D4C1-3C0657816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52C2D-6B39-45F5-BEC3-A17D28DBCB7D}" type="datetimeFigureOut">
              <a:rPr lang="zh-CN" altLang="en-US" smtClean="0"/>
              <a:t>2025/11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5CEC8A4-F74C-86BC-77B6-5C86D3BD58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1B9DB61-470C-A0F3-D64F-8AC9C2BB60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612F-B608-4034-BC25-854815F166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8300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A9903F-2070-E8E8-D72F-C7A1EE25F0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E89FD6E-2981-1E42-0F70-C446DC5926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2163040-6DBC-FA58-1B6C-505CD48980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1A65DDD-EEFD-B7E2-0828-FFCDD4CC72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D52C2D-6B39-45F5-BEC3-A17D28DBCB7D}" type="datetimeFigureOut">
              <a:rPr lang="zh-CN" altLang="en-US" smtClean="0"/>
              <a:t>2025/11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A5B6EA0-DE55-11C4-B1B8-690702EED5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7935284-04F1-166E-F6A7-7134A9A686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612F-B608-4034-BC25-854815F166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9323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8681578-1843-2FF1-DBBB-5F84236D8F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C019AFD-ACE8-FAF8-747A-BCFDBC4144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EB0EA0C-D7B5-3C27-EE40-3FE44A8661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D52C2D-6B39-45F5-BEC3-A17D28DBCB7D}" type="datetimeFigureOut">
              <a:rPr lang="zh-CN" altLang="en-US" smtClean="0"/>
              <a:t>2025/11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9DECF8D-3F39-825F-2B0F-5D41054BFF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A85BBA1-29C1-A5A8-5CA9-0FB3C91E42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E3612F-B608-4034-BC25-854815F166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6896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id="{A5260E68-5996-903A-31C4-BFAF6553E966}"/>
              </a:ext>
            </a:extLst>
          </p:cNvPr>
          <p:cNvSpPr txBox="1"/>
          <p:nvPr/>
        </p:nvSpPr>
        <p:spPr>
          <a:xfrm>
            <a:off x="6449453" y="3547209"/>
            <a:ext cx="13925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</a:rPr>
              <a:t>IB: β-Tubulin</a:t>
            </a:r>
            <a:endParaRPr lang="en-US" sz="1200" dirty="0"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A90D17F-935A-D782-AD7A-8EEFBBF94F44}"/>
              </a:ext>
            </a:extLst>
          </p:cNvPr>
          <p:cNvSpPr txBox="1"/>
          <p:nvPr/>
        </p:nvSpPr>
        <p:spPr>
          <a:xfrm rot="19032761">
            <a:off x="5462179" y="1910960"/>
            <a:ext cx="16943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</a:rPr>
              <a:t>Nub&gt;V5-LATS1-WT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18DD426-F23C-1DD8-34CA-CD4BCD1729A2}"/>
              </a:ext>
            </a:extLst>
          </p:cNvPr>
          <p:cNvSpPr txBox="1"/>
          <p:nvPr/>
        </p:nvSpPr>
        <p:spPr>
          <a:xfrm rot="19032761">
            <a:off x="5929538" y="1910960"/>
            <a:ext cx="16943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</a:rPr>
              <a:t>Nub&gt;V5-LATS1-4A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8AEAD229-3E98-AA4B-D535-4CD9B736A9B0}"/>
              </a:ext>
            </a:extLst>
          </p:cNvPr>
          <p:cNvSpPr txBox="1"/>
          <p:nvPr/>
        </p:nvSpPr>
        <p:spPr>
          <a:xfrm rot="19032761">
            <a:off x="5056876" y="1902681"/>
            <a:ext cx="16943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</a:rPr>
              <a:t>Nub&gt;GFP</a:t>
            </a: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449B3C81-E1A5-7DFD-6A17-5ACD041B9E6D}"/>
              </a:ext>
            </a:extLst>
          </p:cNvPr>
          <p:cNvSpPr/>
          <p:nvPr/>
        </p:nvSpPr>
        <p:spPr>
          <a:xfrm>
            <a:off x="4778852" y="3628350"/>
            <a:ext cx="449162" cy="276999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5 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71B9E0EF-A402-6E29-EA47-64852C8A611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296" t="42383" r="49234" b="53102"/>
          <a:stretch>
            <a:fillRect/>
          </a:stretch>
        </p:blipFill>
        <p:spPr>
          <a:xfrm>
            <a:off x="5188251" y="3448149"/>
            <a:ext cx="1261202" cy="4227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DCA30837-4301-EB38-E6C3-CBE587701FE0}"/>
              </a:ext>
            </a:extLst>
          </p:cNvPr>
          <p:cNvSpPr/>
          <p:nvPr/>
        </p:nvSpPr>
        <p:spPr>
          <a:xfrm>
            <a:off x="4693892" y="2998225"/>
            <a:ext cx="534122" cy="276999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5 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9569D9B5-7637-C6E9-868D-9FD8333E938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28" t="25959" r="34102" b="69527"/>
          <a:stretch>
            <a:fillRect/>
          </a:stretch>
        </p:blipFill>
        <p:spPr>
          <a:xfrm>
            <a:off x="5188251" y="2893070"/>
            <a:ext cx="1261202" cy="4227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72BBD619-B2D8-BEE8-0401-568D41F93468}"/>
              </a:ext>
            </a:extLst>
          </p:cNvPr>
          <p:cNvSpPr txBox="1"/>
          <p:nvPr/>
        </p:nvSpPr>
        <p:spPr>
          <a:xfrm>
            <a:off x="6449453" y="2998225"/>
            <a:ext cx="13925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</a:rPr>
              <a:t>IB: V5</a:t>
            </a:r>
            <a:endParaRPr lang="en-US" sz="1200" dirty="0"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</a:endParaRPr>
          </a:p>
        </p:txBody>
      </p:sp>
      <p:cxnSp>
        <p:nvCxnSpPr>
          <p:cNvPr id="21" name="直接连接符 83">
            <a:extLst>
              <a:ext uri="{FF2B5EF4-FFF2-40B4-BE49-F238E27FC236}">
                <a16:creationId xmlns:a16="http://schemas.microsoft.com/office/drawing/2014/main" id="{868F0B10-3422-844E-A287-B3ABE6FEE10A}"/>
              </a:ext>
            </a:extLst>
          </p:cNvPr>
          <p:cNvCxnSpPr>
            <a:cxnSpLocks/>
          </p:cNvCxnSpPr>
          <p:nvPr/>
        </p:nvCxnSpPr>
        <p:spPr>
          <a:xfrm flipV="1">
            <a:off x="4693892" y="2904462"/>
            <a:ext cx="0" cy="97018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矩形 21">
            <a:extLst>
              <a:ext uri="{FF2B5EF4-FFF2-40B4-BE49-F238E27FC236}">
                <a16:creationId xmlns:a16="http://schemas.microsoft.com/office/drawing/2014/main" id="{FA3B9B5A-6647-EC90-C53F-E31B3B5DD9B3}"/>
              </a:ext>
            </a:extLst>
          </p:cNvPr>
          <p:cNvSpPr/>
          <p:nvPr/>
        </p:nvSpPr>
        <p:spPr>
          <a:xfrm>
            <a:off x="4489850" y="2362827"/>
            <a:ext cx="577704" cy="253906"/>
          </a:xfrm>
          <a:prstGeom prst="rect">
            <a:avLst/>
          </a:prstGeom>
        </p:spPr>
        <p:txBody>
          <a:bodyPr wrap="none" lIns="68571" tIns="34285" rIns="68571" bIns="34285">
            <a:spAutoFit/>
          </a:bodyPr>
          <a:lstStyle/>
          <a:p>
            <a:r>
              <a:rPr lang="en-US" altLang="zh-CN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sz="1200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K)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84">
            <a:extLst>
              <a:ext uri="{FF2B5EF4-FFF2-40B4-BE49-F238E27FC236}">
                <a16:creationId xmlns:a16="http://schemas.microsoft.com/office/drawing/2014/main" id="{A001AFF9-0A74-C451-2EFA-FE274326D2DB}"/>
              </a:ext>
            </a:extLst>
          </p:cNvPr>
          <p:cNvSpPr txBox="1"/>
          <p:nvPr/>
        </p:nvSpPr>
        <p:spPr>
          <a:xfrm rot="16200000">
            <a:off x="3844633" y="3240541"/>
            <a:ext cx="1421516" cy="276999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200" dirty="0"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+mn-ea"/>
              </a:rPr>
              <a:t>Input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60D29425-06A0-F880-8524-0BF1D919E38C}"/>
              </a:ext>
            </a:extLst>
          </p:cNvPr>
          <p:cNvSpPr txBox="1"/>
          <p:nvPr/>
        </p:nvSpPr>
        <p:spPr>
          <a:xfrm>
            <a:off x="1324101" y="4845884"/>
            <a:ext cx="9159938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rgbClr val="0F1115"/>
                </a:solidFill>
                <a:latin typeface="quote-cjk-patch"/>
              </a:rPr>
              <a:t>Supplementary Figure S1. Proteins were extracted from 20 Drosophila larvae using RIPA lysis buffer. The lysate was centrifuged, and the supernatant was used for Western blotting analysis with an anti-V5 antibody.</a:t>
            </a:r>
            <a:endParaRPr lang="zh-CN" altLang="en-US" dirty="0">
              <a:solidFill>
                <a:srgbClr val="0F1115"/>
              </a:solidFill>
              <a:latin typeface="quote-cjk-patch"/>
            </a:endParaRPr>
          </a:p>
        </p:txBody>
      </p:sp>
    </p:spTree>
    <p:extLst>
      <p:ext uri="{BB962C8B-B14F-4D97-AF65-F5344CB8AC3E}">
        <p14:creationId xmlns:p14="http://schemas.microsoft.com/office/powerpoint/2010/main" val="41893967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41</TotalTime>
  <Words>59</Words>
  <Application>Microsoft Office PowerPoint</Application>
  <PresentationFormat>宽屏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quote-cjk-patch</vt:lpstr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ion Incep</dc:creator>
  <cp:lastModifiedBy>Jing Li</cp:lastModifiedBy>
  <cp:revision>94</cp:revision>
  <dcterms:created xsi:type="dcterms:W3CDTF">2025-04-16T06:43:10Z</dcterms:created>
  <dcterms:modified xsi:type="dcterms:W3CDTF">2025-11-12T04:45:37Z</dcterms:modified>
</cp:coreProperties>
</file>